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36" userDrawn="1">
          <p15:clr>
            <a:srgbClr val="A4A3A4"/>
          </p15:clr>
        </p15:guide>
        <p15:guide id="2" pos="5110" userDrawn="1">
          <p15:clr>
            <a:srgbClr val="A4A3A4"/>
          </p15:clr>
        </p15:guide>
        <p15:guide id="3" pos="2378" userDrawn="1">
          <p15:clr>
            <a:srgbClr val="A4A3A4"/>
          </p15:clr>
        </p15:guide>
        <p15:guide id="4" pos="6017" userDrawn="1">
          <p15:clr>
            <a:srgbClr val="A4A3A4"/>
          </p15:clr>
        </p15:guide>
        <p15:guide id="5" pos="937" userDrawn="1">
          <p15:clr>
            <a:srgbClr val="A4A3A4"/>
          </p15:clr>
        </p15:guide>
        <p15:guide id="6" orient="horz" pos="2205" userDrawn="1">
          <p15:clr>
            <a:srgbClr val="A4A3A4"/>
          </p15:clr>
        </p15:guide>
        <p15:guide id="7" orient="horz" pos="1344" userDrawn="1">
          <p15:clr>
            <a:srgbClr val="A4A3A4"/>
          </p15:clr>
        </p15:guide>
        <p15:guide id="8" orient="horz" pos="1797" userDrawn="1">
          <p15:clr>
            <a:srgbClr val="A4A3A4"/>
          </p15:clr>
        </p15:guide>
        <p15:guide id="9" orient="horz" pos="935" userDrawn="1">
          <p15:clr>
            <a:srgbClr val="A4A3A4"/>
          </p15:clr>
        </p15:guide>
        <p15:guide id="10" orient="horz" pos="482" userDrawn="1">
          <p15:clr>
            <a:srgbClr val="A4A3A4"/>
          </p15:clr>
        </p15:guide>
        <p15:guide id="11" orient="horz" pos="304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49AE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01"/>
    <p:restoredTop sz="94762"/>
  </p:normalViewPr>
  <p:slideViewPr>
    <p:cSldViewPr snapToGrid="0" showGuides="1">
      <p:cViewPr varScale="1">
        <p:scale>
          <a:sx n="117" d="100"/>
          <a:sy n="117" d="100"/>
        </p:scale>
        <p:origin x="520" y="168"/>
      </p:cViewPr>
      <p:guideLst>
        <p:guide orient="horz" pos="2636"/>
        <p:guide pos="5110"/>
        <p:guide pos="2378"/>
        <p:guide pos="6017"/>
        <p:guide pos="937"/>
        <p:guide orient="horz" pos="2205"/>
        <p:guide orient="horz" pos="1344"/>
        <p:guide orient="horz" pos="1797"/>
        <p:guide orient="horz" pos="935"/>
        <p:guide orient="horz" pos="482"/>
        <p:guide orient="horz" pos="30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14C665-EFB8-884D-A0BB-DA30FBAABF7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FCFEA9-55BA-314F-98D8-D672DC14B93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339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FCFEA9-55BA-314F-98D8-D672DC14B93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845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4E3086-0B51-A867-F664-184E29FF2B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092D5A7-861E-712A-468A-FC457B5981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6B55A0E-0AA2-4C61-0D3B-DDA5E6B69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E27D32-EF5F-EF04-9995-A1D593891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ADA1AA7-F58B-7B1E-6709-31A155ABE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004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F5129CE-782D-2602-4AB2-7BD7D88919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0C4A82F-4BE7-EE0C-34DB-FA344FE9AA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B89E735-CE02-F751-1C91-BCA9BD021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08FB504-23F8-7080-6808-7FBA85871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D25974-8371-B171-CF35-D9F044CBD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741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1C490F7-3FCA-0BC1-8BAD-6803BAC017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8104658-3C55-DC28-72CB-BBB6E85F1B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C76016-3C6D-06BE-1229-37843086B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CF6AC49-B3E0-0DF3-6761-370BE77BE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010F37D-D137-24AE-9D6D-C88300F39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926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B36349-60D9-9E45-5AF9-7F21EE488A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F2AD4C7-FF88-99F0-97E4-FD31F127DC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AFE8CBA-A891-5573-297B-29BC7E5B1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5B4A3A8-7232-B705-C10F-8D94BA975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BE7DD06-6F59-B3D1-AF7B-62C39E260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0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43C2490-5A92-E715-E80B-90BEA3964E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2E3CA73-152D-8349-0F16-7A3324A5A6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091E973-6E8F-F07E-0382-FBD440DF1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4CA47B-8D11-99B8-6E19-6056C930E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4E45A31-D271-A391-4C1D-D85584854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815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F0751B0-A5A4-8BD0-0833-389E3A9638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5872B82-E6DE-A751-78A8-C39A6E1345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BF2EF1B-DDE4-14F4-D328-1B54EC0A5D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BC94D21-94A6-89B1-CF2F-2C073D5ED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4F199DD-241A-CBD4-B63B-A54E354CF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86A33C2-52A6-37A4-B731-4ECDB7FE6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761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24F810-423A-F7A7-A392-1991B970CF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BCF999E-E41F-745E-B855-646CCB0003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C772BA6-2661-4D43-4A6A-4349F22AC8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39B8B75-3237-8BE5-AD9D-78C5E821E0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DB9FF84-5602-7A4F-2928-15F625ABDF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012A387-EDE1-5520-5D53-661D49F86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E864567-96F8-FF91-3FC8-A6593F887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DDFAA66-528C-C0AE-8C59-40D11245E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4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80EBCD-BAC3-E0C3-15B8-54B2A1C996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D175FD5-D717-4592-D13E-636F7D557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2DE1B06-CD44-4940-83F4-08E0C61C2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3E40A1A-4925-5F2F-D175-6AF706DCD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193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775A8B5-72D7-A7F1-A74A-59246C7CA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DD9EF8F-A1D6-2C44-37AA-1ED35DB2D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A52AD0E-F901-2A7A-13CD-6253ADA99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154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6E7F82-1E6D-CF35-D3BE-749995E3A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6A1AB39-D47F-443D-14EF-70120DD9AE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E7335E8-9993-6A42-040C-932BA161E5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C448B91-9893-D038-2FAE-2A7F1AAECD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1B519A1-F2ED-0393-9EF7-2C267A667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EA5F06D-DBA2-CA35-A56A-0CBCE6916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720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ABBBF4-D760-C931-F693-6554D1177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4143345-CAF1-97E3-2E09-BCCFB90B17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905B5DF-FC24-C3D8-C82B-C8E37984E5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003B798-01F6-6A7F-1FE1-AF70EA553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555C873-C37C-FB14-2114-E935A1C42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0741CB4-7096-4D1A-D083-5B9479279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83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9CF2E79-9E84-DC92-DBFA-109CC8F80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F6AA67A-0EA0-5160-BAD9-4422A3B4DD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3F74FAC-DD98-1C7B-A5D8-829584D067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4ED93-5B05-D744-9A14-FE4190737A10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4641C12-48F6-2BB3-18CD-1B0F1B4666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D83BCC-B659-6EDC-C2E5-FBA2DE8FAD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0D775-8399-4B49-882C-7C1C6440027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946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00989A3F-A84E-F17C-B4C3-6588D4C633E5}"/>
              </a:ext>
            </a:extLst>
          </p:cNvPr>
          <p:cNvSpPr txBox="1"/>
          <p:nvPr/>
        </p:nvSpPr>
        <p:spPr>
          <a:xfrm>
            <a:off x="593889" y="329856"/>
            <a:ext cx="111896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C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US" dirty="0">
                <a:solidFill>
                  <a:srgbClr val="C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ars 2013–2019. D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stribution of cancer cases registered in the Galapagos Archipelago, by age and sex.</a:t>
            </a:r>
          </a:p>
        </p:txBody>
      </p:sp>
      <p:grpSp>
        <p:nvGrpSpPr>
          <p:cNvPr id="60" name="Gruppo 59">
            <a:extLst>
              <a:ext uri="{FF2B5EF4-FFF2-40B4-BE49-F238E27FC236}">
                <a16:creationId xmlns:a16="http://schemas.microsoft.com/office/drawing/2014/main" id="{20A7ED37-9EDE-1EEE-0B3C-CF78AB2CA124}"/>
              </a:ext>
            </a:extLst>
          </p:cNvPr>
          <p:cNvGrpSpPr/>
          <p:nvPr/>
        </p:nvGrpSpPr>
        <p:grpSpPr>
          <a:xfrm>
            <a:off x="2031812" y="1142247"/>
            <a:ext cx="7772867" cy="5315296"/>
            <a:chOff x="2031812" y="1142247"/>
            <a:chExt cx="7772867" cy="5315296"/>
          </a:xfrm>
        </p:grpSpPr>
        <p:sp>
          <p:nvSpPr>
            <p:cNvPr id="55" name="Rettangolo 54">
              <a:extLst>
                <a:ext uri="{FF2B5EF4-FFF2-40B4-BE49-F238E27FC236}">
                  <a16:creationId xmlns:a16="http://schemas.microsoft.com/office/drawing/2014/main" id="{D8CA7A5D-DAC5-BBAA-1D04-6933F3BAC6B0}"/>
                </a:ext>
              </a:extLst>
            </p:cNvPr>
            <p:cNvSpPr/>
            <p:nvPr/>
          </p:nvSpPr>
          <p:spPr>
            <a:xfrm>
              <a:off x="2481013" y="2520844"/>
              <a:ext cx="7027551" cy="684212"/>
            </a:xfrm>
            <a:prstGeom prst="rect">
              <a:avLst/>
            </a:prstGeom>
            <a:solidFill>
              <a:schemeClr val="bg1">
                <a:lumMod val="75000"/>
                <a:alpha val="62243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Rettangolo 55">
              <a:extLst>
                <a:ext uri="{FF2B5EF4-FFF2-40B4-BE49-F238E27FC236}">
                  <a16:creationId xmlns:a16="http://schemas.microsoft.com/office/drawing/2014/main" id="{A0A35476-3580-A613-710B-59E21EDE08D7}"/>
                </a:ext>
              </a:extLst>
            </p:cNvPr>
            <p:cNvSpPr/>
            <p:nvPr/>
          </p:nvSpPr>
          <p:spPr>
            <a:xfrm>
              <a:off x="2484404" y="3887680"/>
              <a:ext cx="7024160" cy="684212"/>
            </a:xfrm>
            <a:prstGeom prst="rect">
              <a:avLst/>
            </a:prstGeom>
            <a:solidFill>
              <a:schemeClr val="bg1">
                <a:lumMod val="75000"/>
                <a:alpha val="62243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Rettangolo 56">
              <a:extLst>
                <a:ext uri="{FF2B5EF4-FFF2-40B4-BE49-F238E27FC236}">
                  <a16:creationId xmlns:a16="http://schemas.microsoft.com/office/drawing/2014/main" id="{4EA60849-0479-BB61-9726-ACAAF9D9E46C}"/>
                </a:ext>
              </a:extLst>
            </p:cNvPr>
            <p:cNvSpPr/>
            <p:nvPr/>
          </p:nvSpPr>
          <p:spPr>
            <a:xfrm>
              <a:off x="2484404" y="5256105"/>
              <a:ext cx="7040378" cy="684212"/>
            </a:xfrm>
            <a:prstGeom prst="rect">
              <a:avLst/>
            </a:prstGeom>
            <a:solidFill>
              <a:schemeClr val="bg1">
                <a:lumMod val="75000"/>
                <a:alpha val="62243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ttangolo 8">
              <a:extLst>
                <a:ext uri="{FF2B5EF4-FFF2-40B4-BE49-F238E27FC236}">
                  <a16:creationId xmlns:a16="http://schemas.microsoft.com/office/drawing/2014/main" id="{5C494501-5807-4BAF-B788-E3F22B1FC8EE}"/>
                </a:ext>
              </a:extLst>
            </p:cNvPr>
            <p:cNvSpPr/>
            <p:nvPr/>
          </p:nvSpPr>
          <p:spPr>
            <a:xfrm>
              <a:off x="2989932" y="5400568"/>
              <a:ext cx="142613" cy="536559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ttangolo 12">
              <a:extLst>
                <a:ext uri="{FF2B5EF4-FFF2-40B4-BE49-F238E27FC236}">
                  <a16:creationId xmlns:a16="http://schemas.microsoft.com/office/drawing/2014/main" id="{E58F0A95-D37E-EE24-A1EE-AC4E7E6277C8}"/>
                </a:ext>
              </a:extLst>
            </p:cNvPr>
            <p:cNvSpPr/>
            <p:nvPr/>
          </p:nvSpPr>
          <p:spPr>
            <a:xfrm>
              <a:off x="4566995" y="5168326"/>
              <a:ext cx="139817" cy="768801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ttangolo 13">
              <a:extLst>
                <a:ext uri="{FF2B5EF4-FFF2-40B4-BE49-F238E27FC236}">
                  <a16:creationId xmlns:a16="http://schemas.microsoft.com/office/drawing/2014/main" id="{D179655D-7AD0-4C5F-253D-86CC00030520}"/>
                </a:ext>
              </a:extLst>
            </p:cNvPr>
            <p:cNvSpPr/>
            <p:nvPr/>
          </p:nvSpPr>
          <p:spPr>
            <a:xfrm>
              <a:off x="4984060" y="4674583"/>
              <a:ext cx="146808" cy="1262544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ttangolo 16">
              <a:extLst>
                <a:ext uri="{FF2B5EF4-FFF2-40B4-BE49-F238E27FC236}">
                  <a16:creationId xmlns:a16="http://schemas.microsoft.com/office/drawing/2014/main" id="{E21AFC82-1A36-998E-B396-B752D730C7ED}"/>
                </a:ext>
              </a:extLst>
            </p:cNvPr>
            <p:cNvSpPr/>
            <p:nvPr/>
          </p:nvSpPr>
          <p:spPr>
            <a:xfrm>
              <a:off x="5812186" y="4158922"/>
              <a:ext cx="138285" cy="1778205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ttangolo 19">
              <a:extLst>
                <a:ext uri="{FF2B5EF4-FFF2-40B4-BE49-F238E27FC236}">
                  <a16:creationId xmlns:a16="http://schemas.microsoft.com/office/drawing/2014/main" id="{9657716B-8BBC-CBE2-4094-9974ED2A37C9}"/>
                </a:ext>
              </a:extLst>
            </p:cNvPr>
            <p:cNvSpPr/>
            <p:nvPr/>
          </p:nvSpPr>
          <p:spPr>
            <a:xfrm>
              <a:off x="7009528" y="4917278"/>
              <a:ext cx="138285" cy="1019849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ttangolo 20">
              <a:extLst>
                <a:ext uri="{FF2B5EF4-FFF2-40B4-BE49-F238E27FC236}">
                  <a16:creationId xmlns:a16="http://schemas.microsoft.com/office/drawing/2014/main" id="{C301215E-7E7A-6A58-7098-186FA0A0E9A7}"/>
                </a:ext>
              </a:extLst>
            </p:cNvPr>
            <p:cNvSpPr/>
            <p:nvPr/>
          </p:nvSpPr>
          <p:spPr>
            <a:xfrm>
              <a:off x="6209740" y="3896424"/>
              <a:ext cx="138285" cy="2040703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ettangolo 21">
              <a:extLst>
                <a:ext uri="{FF2B5EF4-FFF2-40B4-BE49-F238E27FC236}">
                  <a16:creationId xmlns:a16="http://schemas.microsoft.com/office/drawing/2014/main" id="{3E19ECEC-50AB-8F9D-D7B4-2E6C3C01AD97}"/>
                </a:ext>
              </a:extLst>
            </p:cNvPr>
            <p:cNvSpPr/>
            <p:nvPr/>
          </p:nvSpPr>
          <p:spPr>
            <a:xfrm>
              <a:off x="6601509" y="3655984"/>
              <a:ext cx="138285" cy="2281143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ttangolo 22">
              <a:extLst>
                <a:ext uri="{FF2B5EF4-FFF2-40B4-BE49-F238E27FC236}">
                  <a16:creationId xmlns:a16="http://schemas.microsoft.com/office/drawing/2014/main" id="{E570A293-41D8-5E65-E5C1-AA663D598C9C}"/>
                </a:ext>
              </a:extLst>
            </p:cNvPr>
            <p:cNvSpPr/>
            <p:nvPr/>
          </p:nvSpPr>
          <p:spPr>
            <a:xfrm>
              <a:off x="7398725" y="3904925"/>
              <a:ext cx="138285" cy="2032202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ttangolo 24">
              <a:extLst>
                <a:ext uri="{FF2B5EF4-FFF2-40B4-BE49-F238E27FC236}">
                  <a16:creationId xmlns:a16="http://schemas.microsoft.com/office/drawing/2014/main" id="{0E1723B4-9069-2390-4A96-C3659F8E04A5}"/>
                </a:ext>
              </a:extLst>
            </p:cNvPr>
            <p:cNvSpPr/>
            <p:nvPr/>
          </p:nvSpPr>
          <p:spPr>
            <a:xfrm>
              <a:off x="7799689" y="4415557"/>
              <a:ext cx="138285" cy="1521570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ttangolo 27">
              <a:extLst>
                <a:ext uri="{FF2B5EF4-FFF2-40B4-BE49-F238E27FC236}">
                  <a16:creationId xmlns:a16="http://schemas.microsoft.com/office/drawing/2014/main" id="{7FB85459-3766-00A3-3DAE-45FA3E2B3A96}"/>
                </a:ext>
              </a:extLst>
            </p:cNvPr>
            <p:cNvSpPr/>
            <p:nvPr/>
          </p:nvSpPr>
          <p:spPr>
            <a:xfrm>
              <a:off x="8196172" y="4671175"/>
              <a:ext cx="138285" cy="1265952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ttangolo 28">
              <a:extLst>
                <a:ext uri="{FF2B5EF4-FFF2-40B4-BE49-F238E27FC236}">
                  <a16:creationId xmlns:a16="http://schemas.microsoft.com/office/drawing/2014/main" id="{BF29997C-9E81-F32B-E7E0-3B1F4504628C}"/>
                </a:ext>
              </a:extLst>
            </p:cNvPr>
            <p:cNvSpPr/>
            <p:nvPr/>
          </p:nvSpPr>
          <p:spPr>
            <a:xfrm>
              <a:off x="8596905" y="4667532"/>
              <a:ext cx="138285" cy="1269595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ttangolo 29">
              <a:extLst>
                <a:ext uri="{FF2B5EF4-FFF2-40B4-BE49-F238E27FC236}">
                  <a16:creationId xmlns:a16="http://schemas.microsoft.com/office/drawing/2014/main" id="{8388C0D4-5B14-2FC2-E0D7-823E3F53F269}"/>
                </a:ext>
              </a:extLst>
            </p:cNvPr>
            <p:cNvSpPr/>
            <p:nvPr/>
          </p:nvSpPr>
          <p:spPr>
            <a:xfrm>
              <a:off x="8993532" y="4917278"/>
              <a:ext cx="138285" cy="1019849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Rettangolo 32">
              <a:extLst>
                <a:ext uri="{FF2B5EF4-FFF2-40B4-BE49-F238E27FC236}">
                  <a16:creationId xmlns:a16="http://schemas.microsoft.com/office/drawing/2014/main" id="{ECD8692E-33D6-6750-5256-F1997F071D92}"/>
                </a:ext>
              </a:extLst>
            </p:cNvPr>
            <p:cNvSpPr/>
            <p:nvPr/>
          </p:nvSpPr>
          <p:spPr>
            <a:xfrm>
              <a:off x="5410470" y="3407769"/>
              <a:ext cx="138285" cy="2529358"/>
            </a:xfrm>
            <a:prstGeom prst="rect">
              <a:avLst/>
            </a:prstGeom>
            <a:solidFill>
              <a:schemeClr val="bg1">
                <a:lumMod val="50000"/>
                <a:alpha val="54299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AA04895B-4582-7F52-93F1-C4B8EFD8C3B3}"/>
                </a:ext>
              </a:extLst>
            </p:cNvPr>
            <p:cNvSpPr txBox="1"/>
            <p:nvPr/>
          </p:nvSpPr>
          <p:spPr>
            <a:xfrm>
              <a:off x="2778005" y="5945235"/>
              <a:ext cx="397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0-4</a:t>
              </a:r>
              <a:endParaRPr lang="en-US" sz="1600" dirty="0"/>
            </a:p>
          </p:txBody>
        </p:sp>
        <p:cxnSp>
          <p:nvCxnSpPr>
            <p:cNvPr id="37" name="Connettore 1 36">
              <a:extLst>
                <a:ext uri="{FF2B5EF4-FFF2-40B4-BE49-F238E27FC236}">
                  <a16:creationId xmlns:a16="http://schemas.microsoft.com/office/drawing/2014/main" id="{879A365C-36BA-DB1E-C735-3AA220C483F4}"/>
                </a:ext>
              </a:extLst>
            </p:cNvPr>
            <p:cNvCxnSpPr>
              <a:cxnSpLocks/>
            </p:cNvCxnSpPr>
            <p:nvPr/>
          </p:nvCxnSpPr>
          <p:spPr>
            <a:xfrm>
              <a:off x="2481013" y="1142247"/>
              <a:ext cx="0" cy="479807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nettore 1 38">
              <a:extLst>
                <a:ext uri="{FF2B5EF4-FFF2-40B4-BE49-F238E27FC236}">
                  <a16:creationId xmlns:a16="http://schemas.microsoft.com/office/drawing/2014/main" id="{04BFBAAC-0399-D849-ACC8-9DAD294CA9B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2830" y="5940318"/>
              <a:ext cx="729915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FF8F5E36-4241-2EE7-CE4D-F5CE77DE1623}"/>
                </a:ext>
              </a:extLst>
            </p:cNvPr>
            <p:cNvSpPr txBox="1"/>
            <p:nvPr/>
          </p:nvSpPr>
          <p:spPr>
            <a:xfrm>
              <a:off x="3199923" y="6180544"/>
              <a:ext cx="397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5-9</a:t>
              </a:r>
              <a:endParaRPr lang="en-US" sz="1600" dirty="0"/>
            </a:p>
          </p:txBody>
        </p:sp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5C2AA799-1F13-5199-6F9E-EBCB3ADBA38E}"/>
                </a:ext>
              </a:extLst>
            </p:cNvPr>
            <p:cNvSpPr txBox="1"/>
            <p:nvPr/>
          </p:nvSpPr>
          <p:spPr>
            <a:xfrm>
              <a:off x="3526619" y="5945235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10-14</a:t>
              </a:r>
              <a:endParaRPr lang="en-US" sz="1600" dirty="0"/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A96D5448-1E1B-BF27-84F5-C299BED0EED6}"/>
                </a:ext>
              </a:extLst>
            </p:cNvPr>
            <p:cNvSpPr txBox="1"/>
            <p:nvPr/>
          </p:nvSpPr>
          <p:spPr>
            <a:xfrm>
              <a:off x="3916796" y="6180544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15-19</a:t>
              </a:r>
              <a:endParaRPr lang="en-US" sz="1600" dirty="0"/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9C9D2D71-EBD0-AB9A-39E2-8419310F41E0}"/>
                </a:ext>
              </a:extLst>
            </p:cNvPr>
            <p:cNvSpPr txBox="1"/>
            <p:nvPr/>
          </p:nvSpPr>
          <p:spPr>
            <a:xfrm>
              <a:off x="4285221" y="5945235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20-24</a:t>
              </a:r>
              <a:endParaRPr lang="en-US" sz="1600" dirty="0"/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CC11A870-3306-783B-2328-53384BA01DAA}"/>
                </a:ext>
              </a:extLst>
            </p:cNvPr>
            <p:cNvSpPr txBox="1"/>
            <p:nvPr/>
          </p:nvSpPr>
          <p:spPr>
            <a:xfrm>
              <a:off x="4696351" y="6180544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25-29</a:t>
              </a:r>
              <a:endParaRPr lang="en-US" sz="1600" dirty="0"/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465674E6-4987-97D0-0FE3-2809624D661B}"/>
                </a:ext>
              </a:extLst>
            </p:cNvPr>
            <p:cNvSpPr txBox="1"/>
            <p:nvPr/>
          </p:nvSpPr>
          <p:spPr>
            <a:xfrm>
              <a:off x="5125181" y="5945235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30-34</a:t>
              </a:r>
              <a:endParaRPr lang="en-US" sz="1600" dirty="0"/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DDDBE327-9667-0E6B-F4C4-5D6B6F6EF911}"/>
                </a:ext>
              </a:extLst>
            </p:cNvPr>
            <p:cNvSpPr txBox="1"/>
            <p:nvPr/>
          </p:nvSpPr>
          <p:spPr>
            <a:xfrm>
              <a:off x="5522711" y="6180544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35-39</a:t>
              </a:r>
              <a:endParaRPr lang="en-US" sz="1600" dirty="0"/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814584B2-3568-93CB-7846-3DD99781E43B}"/>
                </a:ext>
              </a:extLst>
            </p:cNvPr>
            <p:cNvSpPr txBox="1"/>
            <p:nvPr/>
          </p:nvSpPr>
          <p:spPr>
            <a:xfrm>
              <a:off x="5916986" y="5945235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40-44</a:t>
              </a:r>
              <a:endParaRPr lang="en-US" sz="1600" dirty="0"/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A5AF92CB-BFD8-AC10-F773-66BBA217D104}"/>
                </a:ext>
              </a:extLst>
            </p:cNvPr>
            <p:cNvSpPr txBox="1"/>
            <p:nvPr/>
          </p:nvSpPr>
          <p:spPr>
            <a:xfrm>
              <a:off x="6321317" y="6180544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45-49</a:t>
              </a:r>
              <a:endParaRPr lang="en-US" sz="1600" dirty="0"/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6DF2C9F7-D3FD-A310-5B36-44A5E71D756B}"/>
                </a:ext>
              </a:extLst>
            </p:cNvPr>
            <p:cNvSpPr txBox="1"/>
            <p:nvPr/>
          </p:nvSpPr>
          <p:spPr>
            <a:xfrm>
              <a:off x="6721490" y="5945235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50-54</a:t>
              </a:r>
              <a:endParaRPr lang="en-US" sz="1600" dirty="0"/>
            </a:p>
          </p:txBody>
        </p: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66612CAE-D06B-0D57-94D6-43441993922D}"/>
                </a:ext>
              </a:extLst>
            </p:cNvPr>
            <p:cNvSpPr txBox="1"/>
            <p:nvPr/>
          </p:nvSpPr>
          <p:spPr>
            <a:xfrm>
              <a:off x="7509219" y="5945235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60-64</a:t>
              </a:r>
              <a:endParaRPr lang="en-US" sz="1600" dirty="0"/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0C0E91E4-4A17-4189-8A2B-4F48067FDAC3}"/>
                </a:ext>
              </a:extLst>
            </p:cNvPr>
            <p:cNvSpPr txBox="1"/>
            <p:nvPr/>
          </p:nvSpPr>
          <p:spPr>
            <a:xfrm>
              <a:off x="7113572" y="6180544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55-59</a:t>
              </a:r>
              <a:endParaRPr lang="en-US" sz="1600" dirty="0"/>
            </a:p>
          </p:txBody>
        </p: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38240C21-09F3-F8C8-E980-27C46B4EB567}"/>
                </a:ext>
              </a:extLst>
            </p:cNvPr>
            <p:cNvSpPr txBox="1"/>
            <p:nvPr/>
          </p:nvSpPr>
          <p:spPr>
            <a:xfrm>
              <a:off x="8304649" y="5945235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70-74</a:t>
              </a:r>
              <a:endParaRPr lang="en-US" sz="1600" dirty="0"/>
            </a:p>
          </p:txBody>
        </p:sp>
        <p:sp>
          <p:nvSpPr>
            <p:cNvPr id="46" name="CasellaDiTesto 45">
              <a:extLst>
                <a:ext uri="{FF2B5EF4-FFF2-40B4-BE49-F238E27FC236}">
                  <a16:creationId xmlns:a16="http://schemas.microsoft.com/office/drawing/2014/main" id="{BDED079D-9229-BF41-6CA3-BFF2F04E990D}"/>
                </a:ext>
              </a:extLst>
            </p:cNvPr>
            <p:cNvSpPr txBox="1"/>
            <p:nvPr/>
          </p:nvSpPr>
          <p:spPr>
            <a:xfrm>
              <a:off x="7902652" y="6180544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65-69</a:t>
              </a:r>
              <a:endParaRPr lang="en-US" sz="1600" dirty="0"/>
            </a:p>
          </p:txBody>
        </p:sp>
        <p:sp>
          <p:nvSpPr>
            <p:cNvPr id="47" name="CasellaDiTesto 46">
              <a:extLst>
                <a:ext uri="{FF2B5EF4-FFF2-40B4-BE49-F238E27FC236}">
                  <a16:creationId xmlns:a16="http://schemas.microsoft.com/office/drawing/2014/main" id="{D34BBE26-5975-487B-F02C-EB34B3EDC20E}"/>
                </a:ext>
              </a:extLst>
            </p:cNvPr>
            <p:cNvSpPr txBox="1"/>
            <p:nvPr/>
          </p:nvSpPr>
          <p:spPr>
            <a:xfrm>
              <a:off x="8707374" y="6180544"/>
              <a:ext cx="542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75+</a:t>
              </a:r>
              <a:endParaRPr lang="en-US" sz="1600" dirty="0"/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id="{04798D84-BB75-56B3-3F10-9CC0C5787811}"/>
                </a:ext>
              </a:extLst>
            </p:cNvPr>
            <p:cNvSpPr txBox="1"/>
            <p:nvPr/>
          </p:nvSpPr>
          <p:spPr>
            <a:xfrm>
              <a:off x="2121662" y="5117605"/>
              <a:ext cx="397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2%</a:t>
              </a:r>
              <a:endParaRPr lang="en-US" sz="1600" dirty="0"/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512B6806-3751-3ED8-DF53-B590CCB4246D}"/>
                </a:ext>
              </a:extLst>
            </p:cNvPr>
            <p:cNvSpPr txBox="1"/>
            <p:nvPr/>
          </p:nvSpPr>
          <p:spPr>
            <a:xfrm>
              <a:off x="2121662" y="4408699"/>
              <a:ext cx="397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4%</a:t>
              </a:r>
              <a:endParaRPr lang="en-US" sz="1600" dirty="0"/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396A6B1D-A493-5B71-81CC-22CF7538269B}"/>
                </a:ext>
              </a:extLst>
            </p:cNvPr>
            <p:cNvSpPr txBox="1"/>
            <p:nvPr/>
          </p:nvSpPr>
          <p:spPr>
            <a:xfrm>
              <a:off x="2121662" y="3066555"/>
              <a:ext cx="397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8%</a:t>
              </a:r>
              <a:endParaRPr lang="en-US" sz="1600" dirty="0"/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31B82A01-3482-1BAD-C0C5-A3D785A798C4}"/>
                </a:ext>
              </a:extLst>
            </p:cNvPr>
            <p:cNvSpPr txBox="1"/>
            <p:nvPr/>
          </p:nvSpPr>
          <p:spPr>
            <a:xfrm>
              <a:off x="2121662" y="3749180"/>
              <a:ext cx="397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6%</a:t>
              </a:r>
              <a:endParaRPr lang="en-US" sz="1600" dirty="0"/>
            </a:p>
          </p:txBody>
        </p:sp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2EEF04DD-1930-092C-64DF-086C3581D2FF}"/>
                </a:ext>
              </a:extLst>
            </p:cNvPr>
            <p:cNvSpPr txBox="1"/>
            <p:nvPr/>
          </p:nvSpPr>
          <p:spPr>
            <a:xfrm>
              <a:off x="2031812" y="2382343"/>
              <a:ext cx="487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10%</a:t>
              </a:r>
              <a:endParaRPr lang="en-US" sz="1600" dirty="0"/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11DC2079-BC36-DC0C-73A9-428EA4EF9965}"/>
                </a:ext>
              </a:extLst>
            </p:cNvPr>
            <p:cNvSpPr txBox="1"/>
            <p:nvPr/>
          </p:nvSpPr>
          <p:spPr>
            <a:xfrm>
              <a:off x="2055410" y="1698130"/>
              <a:ext cx="4640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12%</a:t>
              </a:r>
              <a:endParaRPr lang="en-US" sz="1600" dirty="0"/>
            </a:p>
          </p:txBody>
        </p:sp>
        <p:sp>
          <p:nvSpPr>
            <p:cNvPr id="59" name="Rettangolo 58">
              <a:extLst>
                <a:ext uri="{FF2B5EF4-FFF2-40B4-BE49-F238E27FC236}">
                  <a16:creationId xmlns:a16="http://schemas.microsoft.com/office/drawing/2014/main" id="{88A434D9-7C9E-066E-503D-14D166CF8180}"/>
                </a:ext>
              </a:extLst>
            </p:cNvPr>
            <p:cNvSpPr/>
            <p:nvPr/>
          </p:nvSpPr>
          <p:spPr>
            <a:xfrm>
              <a:off x="2484404" y="1152418"/>
              <a:ext cx="7024160" cy="684212"/>
            </a:xfrm>
            <a:prstGeom prst="rect">
              <a:avLst/>
            </a:prstGeom>
            <a:solidFill>
              <a:schemeClr val="bg1">
                <a:lumMod val="75000"/>
                <a:alpha val="62243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id="{4F6863B6-0F31-FDAA-220F-99AB748C66C9}"/>
                </a:ext>
              </a:extLst>
            </p:cNvPr>
            <p:cNvSpPr/>
            <p:nvPr/>
          </p:nvSpPr>
          <p:spPr>
            <a:xfrm>
              <a:off x="2816118" y="5400568"/>
              <a:ext cx="142613" cy="53655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ttangolo 9">
              <a:extLst>
                <a:ext uri="{FF2B5EF4-FFF2-40B4-BE49-F238E27FC236}">
                  <a16:creationId xmlns:a16="http://schemas.microsoft.com/office/drawing/2014/main" id="{CD6E5883-BD18-6B3F-2AB4-21DDA4E4F7D6}"/>
                </a:ext>
              </a:extLst>
            </p:cNvPr>
            <p:cNvSpPr/>
            <p:nvPr/>
          </p:nvSpPr>
          <p:spPr>
            <a:xfrm>
              <a:off x="3251561" y="5400568"/>
              <a:ext cx="142613" cy="53655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ttangolo 10">
              <a:extLst>
                <a:ext uri="{FF2B5EF4-FFF2-40B4-BE49-F238E27FC236}">
                  <a16:creationId xmlns:a16="http://schemas.microsoft.com/office/drawing/2014/main" id="{52699B24-9D59-BFBE-31D1-02E321B5662E}"/>
                </a:ext>
              </a:extLst>
            </p:cNvPr>
            <p:cNvSpPr/>
            <p:nvPr/>
          </p:nvSpPr>
          <p:spPr>
            <a:xfrm>
              <a:off x="3645845" y="5651406"/>
              <a:ext cx="134335" cy="28572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ttangolo 11">
              <a:extLst>
                <a:ext uri="{FF2B5EF4-FFF2-40B4-BE49-F238E27FC236}">
                  <a16:creationId xmlns:a16="http://schemas.microsoft.com/office/drawing/2014/main" id="{A84D5619-E4AD-F2FF-CA34-9F65E5CB80BE}"/>
                </a:ext>
              </a:extLst>
            </p:cNvPr>
            <p:cNvSpPr/>
            <p:nvPr/>
          </p:nvSpPr>
          <p:spPr>
            <a:xfrm>
              <a:off x="4049914" y="5400568"/>
              <a:ext cx="142613" cy="53655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ttangolo 14">
              <a:extLst>
                <a:ext uri="{FF2B5EF4-FFF2-40B4-BE49-F238E27FC236}">
                  <a16:creationId xmlns:a16="http://schemas.microsoft.com/office/drawing/2014/main" id="{EA45C563-1BF2-B760-5781-CD6490F84995}"/>
                </a:ext>
              </a:extLst>
            </p:cNvPr>
            <p:cNvSpPr/>
            <p:nvPr/>
          </p:nvSpPr>
          <p:spPr>
            <a:xfrm>
              <a:off x="5241445" y="5177923"/>
              <a:ext cx="138285" cy="75920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ttangolo 15">
              <a:extLst>
                <a:ext uri="{FF2B5EF4-FFF2-40B4-BE49-F238E27FC236}">
                  <a16:creationId xmlns:a16="http://schemas.microsoft.com/office/drawing/2014/main" id="{1EC7EE1C-5BE8-ED3B-CC95-7FF476093816}"/>
                </a:ext>
              </a:extLst>
            </p:cNvPr>
            <p:cNvSpPr/>
            <p:nvPr/>
          </p:nvSpPr>
          <p:spPr>
            <a:xfrm>
              <a:off x="5641571" y="5177923"/>
              <a:ext cx="138285" cy="75920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ttangolo 17">
              <a:extLst>
                <a:ext uri="{FF2B5EF4-FFF2-40B4-BE49-F238E27FC236}">
                  <a16:creationId xmlns:a16="http://schemas.microsoft.com/office/drawing/2014/main" id="{D877AB92-10A5-BA5E-A1BD-38EFEBC28DCD}"/>
                </a:ext>
              </a:extLst>
            </p:cNvPr>
            <p:cNvSpPr/>
            <p:nvPr/>
          </p:nvSpPr>
          <p:spPr>
            <a:xfrm>
              <a:off x="6033804" y="4917278"/>
              <a:ext cx="138285" cy="101984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ttangolo 18">
              <a:extLst>
                <a:ext uri="{FF2B5EF4-FFF2-40B4-BE49-F238E27FC236}">
                  <a16:creationId xmlns:a16="http://schemas.microsoft.com/office/drawing/2014/main" id="{4C532B47-656C-F4D9-A243-705175FA2439}"/>
                </a:ext>
              </a:extLst>
            </p:cNvPr>
            <p:cNvSpPr/>
            <p:nvPr/>
          </p:nvSpPr>
          <p:spPr>
            <a:xfrm>
              <a:off x="6810291" y="4917278"/>
              <a:ext cx="164306" cy="101984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ttangolo 23">
              <a:extLst>
                <a:ext uri="{FF2B5EF4-FFF2-40B4-BE49-F238E27FC236}">
                  <a16:creationId xmlns:a16="http://schemas.microsoft.com/office/drawing/2014/main" id="{00A54F9D-30B8-BCA8-F2CD-02885395DB88}"/>
                </a:ext>
              </a:extLst>
            </p:cNvPr>
            <p:cNvSpPr/>
            <p:nvPr/>
          </p:nvSpPr>
          <p:spPr>
            <a:xfrm>
              <a:off x="7624592" y="4152651"/>
              <a:ext cx="138285" cy="1784476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ttangolo 25">
              <a:extLst>
                <a:ext uri="{FF2B5EF4-FFF2-40B4-BE49-F238E27FC236}">
                  <a16:creationId xmlns:a16="http://schemas.microsoft.com/office/drawing/2014/main" id="{48750570-17AF-1A82-8E48-4946C523907E}"/>
                </a:ext>
              </a:extLst>
            </p:cNvPr>
            <p:cNvSpPr/>
            <p:nvPr/>
          </p:nvSpPr>
          <p:spPr>
            <a:xfrm>
              <a:off x="8016824" y="4415557"/>
              <a:ext cx="138285" cy="152157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ttangolo 26">
              <a:extLst>
                <a:ext uri="{FF2B5EF4-FFF2-40B4-BE49-F238E27FC236}">
                  <a16:creationId xmlns:a16="http://schemas.microsoft.com/office/drawing/2014/main" id="{199ED9E5-2DC3-1A82-F8F5-98741D0C59A0}"/>
                </a:ext>
              </a:extLst>
            </p:cNvPr>
            <p:cNvSpPr/>
            <p:nvPr/>
          </p:nvSpPr>
          <p:spPr>
            <a:xfrm>
              <a:off x="8413915" y="4415557"/>
              <a:ext cx="138285" cy="152157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ttangolo 30">
              <a:extLst>
                <a:ext uri="{FF2B5EF4-FFF2-40B4-BE49-F238E27FC236}">
                  <a16:creationId xmlns:a16="http://schemas.microsoft.com/office/drawing/2014/main" id="{10849316-12ED-C8CC-7D90-2DB7EBFB1DE2}"/>
                </a:ext>
              </a:extLst>
            </p:cNvPr>
            <p:cNvSpPr/>
            <p:nvPr/>
          </p:nvSpPr>
          <p:spPr>
            <a:xfrm>
              <a:off x="8819506" y="2380436"/>
              <a:ext cx="138285" cy="355669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ttangolo 31">
              <a:extLst>
                <a:ext uri="{FF2B5EF4-FFF2-40B4-BE49-F238E27FC236}">
                  <a16:creationId xmlns:a16="http://schemas.microsoft.com/office/drawing/2014/main" id="{98F8BC5A-84C9-7E07-8263-DBCD90F15282}"/>
                </a:ext>
              </a:extLst>
            </p:cNvPr>
            <p:cNvSpPr/>
            <p:nvPr/>
          </p:nvSpPr>
          <p:spPr>
            <a:xfrm>
              <a:off x="7233662" y="5400568"/>
              <a:ext cx="138285" cy="53655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ttangolo 33">
              <a:extLst>
                <a:ext uri="{FF2B5EF4-FFF2-40B4-BE49-F238E27FC236}">
                  <a16:creationId xmlns:a16="http://schemas.microsoft.com/office/drawing/2014/main" id="{5D7F029F-49B7-2B5D-50C4-B5670AE0F5B2}"/>
                </a:ext>
              </a:extLst>
            </p:cNvPr>
            <p:cNvSpPr/>
            <p:nvPr/>
          </p:nvSpPr>
          <p:spPr>
            <a:xfrm>
              <a:off x="6438035" y="5400568"/>
              <a:ext cx="138285" cy="53655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D0596CA5-575D-91EC-72C2-DF6043E2CF8A}"/>
                </a:ext>
              </a:extLst>
            </p:cNvPr>
            <p:cNvSpPr txBox="1"/>
            <p:nvPr/>
          </p:nvSpPr>
          <p:spPr>
            <a:xfrm>
              <a:off x="2685667" y="1948934"/>
              <a:ext cx="28316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M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id="{6BED1BB4-4507-31DA-B24E-F0448D3FDD16}"/>
                </a:ext>
              </a:extLst>
            </p:cNvPr>
            <p:cNvSpPr txBox="1"/>
            <p:nvPr/>
          </p:nvSpPr>
          <p:spPr>
            <a:xfrm>
              <a:off x="3070453" y="1948934"/>
              <a:ext cx="283169" cy="369332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chemeClr val="bg1"/>
                  </a:solidFill>
                </a:rPr>
                <a:t>F</a:t>
              </a:r>
            </a:p>
          </p:txBody>
        </p: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410322BB-C7F5-641F-FB3A-25116A68FEBF}"/>
                </a:ext>
              </a:extLst>
            </p:cNvPr>
            <p:cNvSpPr txBox="1"/>
            <p:nvPr/>
          </p:nvSpPr>
          <p:spPr>
            <a:xfrm>
              <a:off x="9120100" y="5945235"/>
              <a:ext cx="68457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AG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336486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5</TotalTime>
  <Words>55</Words>
  <Application>Microsoft Macintosh PowerPoint</Application>
  <PresentationFormat>Widescreen</PresentationFormat>
  <Paragraphs>28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ugge massimo</dc:creator>
  <cp:lastModifiedBy>Massimo Rugge</cp:lastModifiedBy>
  <cp:revision>14</cp:revision>
  <dcterms:created xsi:type="dcterms:W3CDTF">2024-01-19T12:34:49Z</dcterms:created>
  <dcterms:modified xsi:type="dcterms:W3CDTF">2024-08-16T17:57:57Z</dcterms:modified>
</cp:coreProperties>
</file>